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335713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BA9820-791C-412C-BFF2-D50CD81081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A3C20-3AC3-44BD-9807-6F3B9DF71E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23FBE-81E4-4CDD-A0F9-AF976C947B5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4568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173840" y="23112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752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4568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173840" y="5725800"/>
            <a:ext cx="18360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00871D-B0FC-468D-AC17-40A16931AB1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DEB483-705D-442F-B22F-CF45CB831F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CF8C1-D53A-42D3-B6E7-BD9B92BADB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702A8-9443-48C8-B15F-C1D8867186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4514C-B169-48CA-BA0C-4B4400EDE0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7520" y="396360"/>
            <a:ext cx="57024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CC4DA-8EC8-403D-A83F-1505BB9D57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307EA-850A-4C53-94A5-11DDD2237E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239640" y="57258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6EF69-DF2E-48AE-885B-14C656041A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752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239640" y="2311200"/>
            <a:ext cx="278244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7520" y="5725800"/>
            <a:ext cx="57024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D29A24-B804-4FFC-832E-05076B1EF7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7520" y="396360"/>
            <a:ext cx="57024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 Unicode MS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7520" y="2311200"/>
            <a:ext cx="57024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 Unicode MS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 Unicode M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7160" y="9182160"/>
            <a:ext cx="14778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65400" y="9182160"/>
            <a:ext cx="200664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41760" y="9182160"/>
            <a:ext cx="147816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232C9B-8008-4541-83B8-87DC7253A30B}" type="slidenum">
              <a:rPr b="0" lang="ja-JP" sz="1200" spc="-1" strike="noStrike">
                <a:solidFill>
                  <a:srgbClr val="898989"/>
                </a:solidFill>
                <a:latin typeface="Arial Unicode MS"/>
                <a:ea typeface="Arial Unicode MS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24"/>
          <p:cNvSpPr/>
          <p:nvPr/>
        </p:nvSpPr>
        <p:spPr>
          <a:xfrm>
            <a:off x="2487600" y="1868400"/>
            <a:ext cx="12654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Full length PAR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36"/>
          <p:cNvSpPr/>
          <p:nvPr/>
        </p:nvSpPr>
        <p:spPr>
          <a:xfrm>
            <a:off x="549000" y="2390760"/>
            <a:ext cx="358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75</a:t>
            </a:r>
            <a:r>
              <a:rPr b="0" lang="ja-JP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6"/>
          <p:cNvSpPr/>
          <p:nvPr/>
        </p:nvSpPr>
        <p:spPr>
          <a:xfrm>
            <a:off x="491760" y="2016000"/>
            <a:ext cx="416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100</a:t>
            </a:r>
            <a:r>
              <a:rPr b="0" lang="ja-JP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 </a:t>
            </a: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7"/>
          <p:cNvSpPr/>
          <p:nvPr/>
        </p:nvSpPr>
        <p:spPr>
          <a:xfrm>
            <a:off x="491760" y="1619280"/>
            <a:ext cx="416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150 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27"/>
          <p:cNvSpPr/>
          <p:nvPr/>
        </p:nvSpPr>
        <p:spPr>
          <a:xfrm>
            <a:off x="498600" y="1430280"/>
            <a:ext cx="3711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kD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正方形/長方形 12"/>
          <p:cNvSpPr/>
          <p:nvPr/>
        </p:nvSpPr>
        <p:spPr>
          <a:xfrm>
            <a:off x="2506320" y="2262240"/>
            <a:ext cx="99756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Cleaved PAR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7" name="直線矢印コネクタ 13"/>
          <p:cNvCxnSpPr/>
          <p:nvPr/>
        </p:nvCxnSpPr>
        <p:spPr>
          <a:xfrm flipH="1">
            <a:off x="2359800" y="1999800"/>
            <a:ext cx="18180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sm"/>
          </a:ln>
        </p:spPr>
      </p:cxnSp>
      <p:cxnSp>
        <p:nvCxnSpPr>
          <p:cNvPr id="48" name="直線矢印コネクタ 14"/>
          <p:cNvCxnSpPr/>
          <p:nvPr/>
        </p:nvCxnSpPr>
        <p:spPr>
          <a:xfrm flipH="1">
            <a:off x="2359800" y="2388960"/>
            <a:ext cx="18180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sm"/>
          </a:ln>
        </p:spPr>
      </p:cxnSp>
      <p:pic>
        <p:nvPicPr>
          <p:cNvPr id="49" name="Picture 2" descr="F:\マイドキュメント（同期）\C7059\Western Blotting\120210 RKO serum starvation\120210 RKO serum starvation ACTB.bmp"/>
          <p:cNvPicPr/>
          <p:nvPr/>
        </p:nvPicPr>
        <p:blipFill>
          <a:blip r:embed="rId1">
            <a:grayscl/>
          </a:blip>
          <a:srcRect l="4074" t="0" r="26880" b="5556"/>
          <a:stretch/>
        </p:blipFill>
        <p:spPr>
          <a:xfrm>
            <a:off x="851040" y="3144960"/>
            <a:ext cx="1439640" cy="390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0" name="Picture 5" descr="K:\マイドキュメント（同期）\C7059\Western Blotting\120210 RKO serum starvation\120113 RKO anoikis 2nd trial PARP strip 2P3.bmp"/>
          <p:cNvPicPr/>
          <p:nvPr/>
        </p:nvPicPr>
        <p:blipFill>
          <a:blip r:embed="rId2">
            <a:grayscl/>
          </a:blip>
          <a:srcRect l="2053" t="22923" r="26906" b="7163"/>
          <a:stretch/>
        </p:blipFill>
        <p:spPr>
          <a:xfrm>
            <a:off x="851040" y="2697120"/>
            <a:ext cx="1439640" cy="389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1" name="テキスト ボックス 26"/>
          <p:cNvSpPr/>
          <p:nvPr/>
        </p:nvSpPr>
        <p:spPr>
          <a:xfrm>
            <a:off x="2270160" y="3216240"/>
            <a:ext cx="58428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CT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41"/>
          <p:cNvSpPr/>
          <p:nvPr/>
        </p:nvSpPr>
        <p:spPr>
          <a:xfrm>
            <a:off x="2270160" y="2768760"/>
            <a:ext cx="7650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FAP1L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8"/>
          <p:cNvSpPr/>
          <p:nvPr/>
        </p:nvSpPr>
        <p:spPr>
          <a:xfrm rot="16200000">
            <a:off x="749520" y="1214640"/>
            <a:ext cx="6818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Parent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9"/>
          <p:cNvSpPr/>
          <p:nvPr/>
        </p:nvSpPr>
        <p:spPr>
          <a:xfrm rot="16200000">
            <a:off x="1212480" y="1177920"/>
            <a:ext cx="69552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AFAP1L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32"/>
          <p:cNvSpPr/>
          <p:nvPr/>
        </p:nvSpPr>
        <p:spPr>
          <a:xfrm rot="16200000">
            <a:off x="1803240" y="1316520"/>
            <a:ext cx="45324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LacZ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線コネクタ 24"/>
          <p:cNvSpPr/>
          <p:nvPr/>
        </p:nvSpPr>
        <p:spPr>
          <a:xfrm>
            <a:off x="973080" y="922320"/>
            <a:ext cx="117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25"/>
          <p:cNvSpPr/>
          <p:nvPr/>
        </p:nvSpPr>
        <p:spPr>
          <a:xfrm>
            <a:off x="1338840" y="665280"/>
            <a:ext cx="43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RK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5" descr="K:\マイドキュメント（同期）\C7059\論文draft\作業中\120210 RKO serum starvation PARP 3.bmp"/>
          <p:cNvPicPr/>
          <p:nvPr/>
        </p:nvPicPr>
        <p:blipFill>
          <a:blip r:embed="rId3">
            <a:lum bright="-10000"/>
          </a:blip>
          <a:srcRect l="39868" t="42303" r="41640" b="38627"/>
          <a:stretch/>
        </p:blipFill>
        <p:spPr>
          <a:xfrm>
            <a:off x="847800" y="1657440"/>
            <a:ext cx="1439640" cy="99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9" name="テキスト ボックス 141"/>
          <p:cNvSpPr/>
          <p:nvPr/>
        </p:nvSpPr>
        <p:spPr>
          <a:xfrm>
            <a:off x="-25560" y="0"/>
            <a:ext cx="1767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Supplementary Figure S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10T07:50:08Z</dcterms:created>
  <dc:creator>Ryo　Takahashi</dc:creator>
  <dc:description/>
  <dc:language>en-US</dc:language>
  <cp:lastModifiedBy>戸口田 淳也</cp:lastModifiedBy>
  <dcterms:modified xsi:type="dcterms:W3CDTF">2013-09-16T07:21:54Z</dcterms:modified>
  <cp:revision>50</cp:revision>
  <dc:subject/>
  <dc:title>スライド 1</dc:title>
</cp:coreProperties>
</file>